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53" y="97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25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185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547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240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567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818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338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1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731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699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981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6A9910-D266-470D-A10E-7F7D60CDBDC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BB5527-BF52-4A52-9C05-B92A7B542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1234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896" y="426069"/>
            <a:ext cx="8542588" cy="5485448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965200" y="5680684"/>
            <a:ext cx="11057467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32</a:t>
            </a: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 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orrelation between β-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nd 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µM) 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or quinoline, phenyl benzamides,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4-benzamidopyridine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quinazoline, carbazole, nicotinamide and miscellaneous compounds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gainst sensitive strain D6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70202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9:03Z</dcterms:created>
  <dcterms:modified xsi:type="dcterms:W3CDTF">2020-08-04T16:38:26Z</dcterms:modified>
</cp:coreProperties>
</file>